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95" userDrawn="1">
          <p15:clr>
            <a:srgbClr val="A4A3A4"/>
          </p15:clr>
        </p15:guide>
        <p15:guide id="2" pos="2502" userDrawn="1">
          <p15:clr>
            <a:srgbClr val="A4A3A4"/>
          </p15:clr>
        </p15:guide>
        <p15:guide id="3" orient="horz" pos="40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68" d="100"/>
          <a:sy n="68" d="100"/>
        </p:scale>
        <p:origin x="356" y="60"/>
      </p:cViewPr>
      <p:guideLst>
        <p:guide orient="horz" pos="2795"/>
        <p:guide pos="2502"/>
        <p:guide orient="horz" pos="40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0987479721195571E-2"/>
          <c:y val="4.2950514328181665E-2"/>
          <c:w val="0.91645160996938424"/>
          <c:h val="0.667531102133025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2:$B$40</c:f>
              <c:strCache>
                <c:ptCount val="39"/>
                <c:pt idx="0">
                  <c:v>Norway</c:v>
                </c:pt>
                <c:pt idx="1">
                  <c:v>Sweden pop 3</c:v>
                </c:pt>
                <c:pt idx="2">
                  <c:v>Finland</c:v>
                </c:pt>
                <c:pt idx="3">
                  <c:v>Sweden</c:v>
                </c:pt>
                <c:pt idx="4">
                  <c:v>Sweden pop 2</c:v>
                </c:pt>
                <c:pt idx="5">
                  <c:v>Ireland Northern pop 3</c:v>
                </c:pt>
                <c:pt idx="6">
                  <c:v>England pop 5</c:v>
                </c:pt>
                <c:pt idx="7">
                  <c:v>England Norwest Mixed</c:v>
                </c:pt>
                <c:pt idx="8">
                  <c:v>Ireland South</c:v>
                </c:pt>
                <c:pt idx="9">
                  <c:v>Germany pop 2</c:v>
                </c:pt>
                <c:pt idx="10">
                  <c:v>England pop 3</c:v>
                </c:pt>
                <c:pt idx="11">
                  <c:v>Germany Essen</c:v>
                </c:pt>
                <c:pt idx="12">
                  <c:v>United Kingdom</c:v>
                </c:pt>
                <c:pt idx="13">
                  <c:v>Belgium</c:v>
                </c:pt>
                <c:pt idx="14">
                  <c:v>Czech Republic</c:v>
                </c:pt>
                <c:pt idx="15">
                  <c:v>France Rennes</c:v>
                </c:pt>
                <c:pt idx="16">
                  <c:v>Austria</c:v>
                </c:pt>
                <c:pt idx="17">
                  <c:v>Austria pop 2</c:v>
                </c:pt>
                <c:pt idx="18">
                  <c:v>Slovakia</c:v>
                </c:pt>
                <c:pt idx="19">
                  <c:v>France West Breton</c:v>
                </c:pt>
                <c:pt idx="20">
                  <c:v>France Lille</c:v>
                </c:pt>
                <c:pt idx="21">
                  <c:v>France Southeasr</c:v>
                </c:pt>
                <c:pt idx="22">
                  <c:v>Italy Bergamo</c:v>
                </c:pt>
                <c:pt idx="23">
                  <c:v>France ceph</c:v>
                </c:pt>
                <c:pt idx="24">
                  <c:v>Spain Navarre Basques</c:v>
                </c:pt>
                <c:pt idx="25">
                  <c:v>Spain Gipuzkoa Basque</c:v>
                </c:pt>
                <c:pt idx="26">
                  <c:v>Italy North pop 3</c:v>
                </c:pt>
                <c:pt idx="27">
                  <c:v>Italy North popn3</c:v>
                </c:pt>
                <c:pt idx="28">
                  <c:v>Italy Turin</c:v>
                </c:pt>
                <c:pt idx="29">
                  <c:v>Spain Catalonia Girona</c:v>
                </c:pt>
                <c:pt idx="30">
                  <c:v>Italy Central</c:v>
                </c:pt>
                <c:pt idx="31">
                  <c:v>Italy Rome</c:v>
                </c:pt>
                <c:pt idx="32">
                  <c:v>Italy Sardinia pop 4</c:v>
                </c:pt>
                <c:pt idx="33">
                  <c:v>Greece</c:v>
                </c:pt>
                <c:pt idx="34">
                  <c:v>Greece pop 4</c:v>
                </c:pt>
                <c:pt idx="35">
                  <c:v>Greece pop 6</c:v>
                </c:pt>
                <c:pt idx="36">
                  <c:v>Greece pop 8</c:v>
                </c:pt>
                <c:pt idx="37">
                  <c:v>Spain Andalusia</c:v>
                </c:pt>
                <c:pt idx="38">
                  <c:v>Spain Andalusia Gypsy</c:v>
                </c:pt>
              </c:strCache>
            </c:strRef>
          </c:cat>
          <c:val>
            <c:numRef>
              <c:f>Sheet1!$C$2:$C$40</c:f>
              <c:numCache>
                <c:formatCode>General</c:formatCode>
                <c:ptCount val="39"/>
                <c:pt idx="0">
                  <c:v>0.47</c:v>
                </c:pt>
                <c:pt idx="1">
                  <c:v>0.44800000000000001</c:v>
                </c:pt>
                <c:pt idx="2">
                  <c:v>0.4</c:v>
                </c:pt>
                <c:pt idx="3">
                  <c:v>0.46</c:v>
                </c:pt>
                <c:pt idx="4">
                  <c:v>0.42499999999999999</c:v>
                </c:pt>
                <c:pt idx="5">
                  <c:v>0.51600000000000001</c:v>
                </c:pt>
                <c:pt idx="6">
                  <c:v>0.39300000000000002</c:v>
                </c:pt>
                <c:pt idx="7">
                  <c:v>0.41699999999999998</c:v>
                </c:pt>
                <c:pt idx="8">
                  <c:v>0.48</c:v>
                </c:pt>
                <c:pt idx="9">
                  <c:v>0.40300000000000002</c:v>
                </c:pt>
                <c:pt idx="10">
                  <c:v>0.435</c:v>
                </c:pt>
                <c:pt idx="11">
                  <c:v>0.39800000000000002</c:v>
                </c:pt>
                <c:pt idx="12">
                  <c:v>0.45</c:v>
                </c:pt>
                <c:pt idx="13">
                  <c:v>0.39600000000000002</c:v>
                </c:pt>
                <c:pt idx="14">
                  <c:v>0.39100000000000001</c:v>
                </c:pt>
                <c:pt idx="15">
                  <c:v>0.45200000000000001</c:v>
                </c:pt>
                <c:pt idx="16">
                  <c:v>0.39900000000000002</c:v>
                </c:pt>
                <c:pt idx="17">
                  <c:v>0.443</c:v>
                </c:pt>
                <c:pt idx="18">
                  <c:v>0.433</c:v>
                </c:pt>
                <c:pt idx="19">
                  <c:v>0.41</c:v>
                </c:pt>
                <c:pt idx="20">
                  <c:v>0.36799999999999999</c:v>
                </c:pt>
                <c:pt idx="21">
                  <c:v>0.42499999999999999</c:v>
                </c:pt>
                <c:pt idx="22">
                  <c:v>0.317</c:v>
                </c:pt>
                <c:pt idx="23">
                  <c:v>0.40899999999999997</c:v>
                </c:pt>
                <c:pt idx="24">
                  <c:v>0.307</c:v>
                </c:pt>
                <c:pt idx="25">
                  <c:v>0.40699999999999997</c:v>
                </c:pt>
                <c:pt idx="26">
                  <c:v>0.44</c:v>
                </c:pt>
                <c:pt idx="27">
                  <c:v>0.44</c:v>
                </c:pt>
                <c:pt idx="28">
                  <c:v>0.379</c:v>
                </c:pt>
                <c:pt idx="29">
                  <c:v>0.40400000000000003</c:v>
                </c:pt>
                <c:pt idx="30">
                  <c:v>0.314</c:v>
                </c:pt>
                <c:pt idx="31">
                  <c:v>0.26</c:v>
                </c:pt>
                <c:pt idx="32">
                  <c:v>0.26529999999999998</c:v>
                </c:pt>
                <c:pt idx="33">
                  <c:v>0.39</c:v>
                </c:pt>
                <c:pt idx="34">
                  <c:v>0.34599999999999997</c:v>
                </c:pt>
                <c:pt idx="35">
                  <c:v>0.33879999999999999</c:v>
                </c:pt>
                <c:pt idx="36">
                  <c:v>0.24099999999999999</c:v>
                </c:pt>
                <c:pt idx="37">
                  <c:v>0.32400000000000001</c:v>
                </c:pt>
                <c:pt idx="38">
                  <c:v>0.343999999999999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886408"/>
        <c:axId val="425884840"/>
      </c:barChart>
      <c:catAx>
        <c:axId val="425886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25884840"/>
        <c:crosses val="autoZero"/>
        <c:auto val="1"/>
        <c:lblAlgn val="ctr"/>
        <c:lblOffset val="100"/>
        <c:tickLblSkip val="1"/>
        <c:noMultiLvlLbl val="0"/>
      </c:catAx>
      <c:valAx>
        <c:axId val="425884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258864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C2C59E-1267-4F5E-9DDB-D5B401E3236B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D9DDDC-69CD-4453-8452-0625FA55DDC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933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45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054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897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503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784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58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4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201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066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18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774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980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直線矢印コネクタ 7"/>
          <p:cNvCxnSpPr/>
          <p:nvPr/>
        </p:nvCxnSpPr>
        <p:spPr>
          <a:xfrm flipV="1">
            <a:off x="2611560" y="5445434"/>
            <a:ext cx="6814285" cy="3873"/>
          </a:xfrm>
          <a:prstGeom prst="straightConnector1">
            <a:avLst/>
          </a:prstGeom>
          <a:ln w="44450"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2022938" y="5290930"/>
            <a:ext cx="5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orth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9539848" y="5290930"/>
            <a:ext cx="576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outh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 rot="16200000">
            <a:off x="1151310" y="2405264"/>
            <a:ext cx="2268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DPB1*04:01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llele frequenci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6" name="グラフ 9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1760454"/>
              </p:ext>
            </p:extLst>
          </p:nvPr>
        </p:nvGraphicFramePr>
        <p:xfrm>
          <a:off x="2676941" y="596349"/>
          <a:ext cx="7036904" cy="4731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5</TotalTime>
  <Words>5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土屋尚之</dc:creator>
  <cp:lastModifiedBy>土屋尚之</cp:lastModifiedBy>
  <cp:revision>184</cp:revision>
  <dcterms:created xsi:type="dcterms:W3CDTF">2014-11-29T09:59:13Z</dcterms:created>
  <dcterms:modified xsi:type="dcterms:W3CDTF">2016-04-26T04:37:42Z</dcterms:modified>
</cp:coreProperties>
</file>